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651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288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085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177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121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021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090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08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2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09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531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31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85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4984" y="3893819"/>
            <a:ext cx="2486216" cy="17066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799" y="3893819"/>
            <a:ext cx="2557082" cy="17066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004" y="3893819"/>
            <a:ext cx="2557082" cy="17066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6404" y="2053351"/>
            <a:ext cx="2557082" cy="17066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4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0379" y="2053351"/>
            <a:ext cx="2486216" cy="17066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5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004" y="2053351"/>
            <a:ext cx="2557082" cy="17066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6404" y="76199"/>
            <a:ext cx="2557082" cy="18720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004" y="76199"/>
            <a:ext cx="2557082" cy="18720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feld 25"/>
          <p:cNvSpPr txBox="1"/>
          <p:nvPr/>
        </p:nvSpPr>
        <p:spPr>
          <a:xfrm>
            <a:off x="898953" y="762000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1186431" y="762000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501592" y="762000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1776140" y="762000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2083798" y="762000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2411850" y="762000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799" y="76199"/>
            <a:ext cx="2557082" cy="18720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Textfeld 31"/>
          <p:cNvSpPr txBox="1"/>
          <p:nvPr/>
        </p:nvSpPr>
        <p:spPr>
          <a:xfrm>
            <a:off x="4109040" y="439579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78781" y="762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925222" y="762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486400" y="762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0" y="5943600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ld change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mpester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/d/g)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anoster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/e/h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cholestero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/f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cortex (top), liver (middle), and plasma (bottom). Fold changes from male C57BL/6J mice fed a coconut oil-based high-fat diet (HF) from age 8 to 32 weeks followed by a standard chow diet (SC) from 32 to 44 weeks of age. Fold changes were calculated relative to animals continuously fed a SC and were set to 1 (dashed line). Statistics: Student’s t test with p&lt;0.05*, p&lt;0.01**, p&lt;0.001***, p&lt;0.0001****.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381000" y="19050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2927441" y="19050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5488619" y="190500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381000" y="37338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2927441" y="37338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5488619" y="3733800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889554" y="4918234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1194354" y="4918234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1495055" y="4830445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1849438" y="447532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2108645" y="425005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2417544" y="425005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914400" y="3057287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1219200" y="3057287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1544748" y="2981087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034501" y="4156233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4343400" y="4610901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4677146" y="4610900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499440" y="2866787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4364148" y="277296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4962861" y="447531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7208394" y="240958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5991114" y="4321114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6296057" y="4036455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6582163" y="4326255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7233240" y="453723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7538040" y="4544849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 rot="16200000">
            <a:off x="-161560" y="780988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 rot="16200000">
            <a:off x="-91830" y="2652561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 rot="16200000">
            <a:off x="-179410" y="4516256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957526" y="304800"/>
            <a:ext cx="1682496" cy="118872"/>
            <a:chOff x="957526" y="399812"/>
            <a:chExt cx="1645920" cy="91440"/>
          </a:xfrm>
        </p:grpSpPr>
        <p:sp>
          <p:nvSpPr>
            <p:cNvPr id="72" name="Rechteck 71"/>
            <p:cNvSpPr/>
            <p:nvPr/>
          </p:nvSpPr>
          <p:spPr>
            <a:xfrm>
              <a:off x="957526" y="399812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hteck 72"/>
            <p:cNvSpPr/>
            <p:nvPr/>
          </p:nvSpPr>
          <p:spPr>
            <a:xfrm>
              <a:off x="1780486" y="399812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uppieren 1"/>
          <p:cNvGrpSpPr/>
          <p:nvPr/>
        </p:nvGrpSpPr>
        <p:grpSpPr>
          <a:xfrm>
            <a:off x="3514725" y="304800"/>
            <a:ext cx="1682496" cy="118872"/>
            <a:chOff x="3535680" y="381000"/>
            <a:chExt cx="1645920" cy="91440"/>
          </a:xfrm>
        </p:grpSpPr>
        <p:sp>
          <p:nvSpPr>
            <p:cNvPr id="74" name="Rechteck 73"/>
            <p:cNvSpPr/>
            <p:nvPr/>
          </p:nvSpPr>
          <p:spPr>
            <a:xfrm>
              <a:off x="3535680" y="381000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hteck 74"/>
            <p:cNvSpPr/>
            <p:nvPr/>
          </p:nvSpPr>
          <p:spPr>
            <a:xfrm>
              <a:off x="4358640" y="381000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Gruppieren 75"/>
          <p:cNvGrpSpPr/>
          <p:nvPr/>
        </p:nvGrpSpPr>
        <p:grpSpPr>
          <a:xfrm>
            <a:off x="6067152" y="304800"/>
            <a:ext cx="1682496" cy="118872"/>
            <a:chOff x="957526" y="399812"/>
            <a:chExt cx="1645920" cy="91440"/>
          </a:xfrm>
        </p:grpSpPr>
        <p:sp>
          <p:nvSpPr>
            <p:cNvPr id="77" name="Rechteck 76"/>
            <p:cNvSpPr/>
            <p:nvPr/>
          </p:nvSpPr>
          <p:spPr>
            <a:xfrm>
              <a:off x="957526" y="399812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hteck 77"/>
            <p:cNvSpPr/>
            <p:nvPr/>
          </p:nvSpPr>
          <p:spPr>
            <a:xfrm>
              <a:off x="1780486" y="399812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9" name="Gruppieren 78"/>
          <p:cNvGrpSpPr/>
          <p:nvPr/>
        </p:nvGrpSpPr>
        <p:grpSpPr>
          <a:xfrm>
            <a:off x="6067152" y="2118360"/>
            <a:ext cx="1682496" cy="118872"/>
            <a:chOff x="957526" y="399812"/>
            <a:chExt cx="1645920" cy="91440"/>
          </a:xfrm>
        </p:grpSpPr>
        <p:sp>
          <p:nvSpPr>
            <p:cNvPr id="80" name="Rechteck 79"/>
            <p:cNvSpPr/>
            <p:nvPr/>
          </p:nvSpPr>
          <p:spPr>
            <a:xfrm>
              <a:off x="957526" y="399812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hteck 80"/>
            <p:cNvSpPr/>
            <p:nvPr/>
          </p:nvSpPr>
          <p:spPr>
            <a:xfrm>
              <a:off x="1780486" y="399812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2" name="Gruppieren 81"/>
          <p:cNvGrpSpPr/>
          <p:nvPr/>
        </p:nvGrpSpPr>
        <p:grpSpPr>
          <a:xfrm>
            <a:off x="6067152" y="3919728"/>
            <a:ext cx="1682496" cy="118872"/>
            <a:chOff x="957526" y="399812"/>
            <a:chExt cx="1645920" cy="91440"/>
          </a:xfrm>
        </p:grpSpPr>
        <p:sp>
          <p:nvSpPr>
            <p:cNvPr id="83" name="Rechteck 82"/>
            <p:cNvSpPr/>
            <p:nvPr/>
          </p:nvSpPr>
          <p:spPr>
            <a:xfrm>
              <a:off x="957526" y="399812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hteck 83"/>
            <p:cNvSpPr/>
            <p:nvPr/>
          </p:nvSpPr>
          <p:spPr>
            <a:xfrm>
              <a:off x="1780486" y="399812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Gruppieren 84"/>
          <p:cNvGrpSpPr/>
          <p:nvPr/>
        </p:nvGrpSpPr>
        <p:grpSpPr>
          <a:xfrm>
            <a:off x="3514725" y="2118360"/>
            <a:ext cx="1682496" cy="118872"/>
            <a:chOff x="3535680" y="381000"/>
            <a:chExt cx="1645920" cy="91440"/>
          </a:xfrm>
        </p:grpSpPr>
        <p:sp>
          <p:nvSpPr>
            <p:cNvPr id="86" name="Rechteck 85"/>
            <p:cNvSpPr/>
            <p:nvPr/>
          </p:nvSpPr>
          <p:spPr>
            <a:xfrm>
              <a:off x="3535680" y="381000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hteck 86"/>
            <p:cNvSpPr/>
            <p:nvPr/>
          </p:nvSpPr>
          <p:spPr>
            <a:xfrm>
              <a:off x="4358640" y="381000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Gruppieren 87"/>
          <p:cNvGrpSpPr/>
          <p:nvPr/>
        </p:nvGrpSpPr>
        <p:grpSpPr>
          <a:xfrm>
            <a:off x="3514725" y="3904488"/>
            <a:ext cx="1682496" cy="118872"/>
            <a:chOff x="3535680" y="381000"/>
            <a:chExt cx="1645920" cy="91440"/>
          </a:xfrm>
        </p:grpSpPr>
        <p:sp>
          <p:nvSpPr>
            <p:cNvPr id="89" name="Rechteck 88"/>
            <p:cNvSpPr/>
            <p:nvPr/>
          </p:nvSpPr>
          <p:spPr>
            <a:xfrm>
              <a:off x="3535680" y="381000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hteck 89"/>
            <p:cNvSpPr/>
            <p:nvPr/>
          </p:nvSpPr>
          <p:spPr>
            <a:xfrm>
              <a:off x="4358640" y="381000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" name="Textfeld 55"/>
          <p:cNvSpPr txBox="1"/>
          <p:nvPr/>
        </p:nvSpPr>
        <p:spPr>
          <a:xfrm>
            <a:off x="3743630" y="4023360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Gruppieren 90"/>
          <p:cNvGrpSpPr/>
          <p:nvPr/>
        </p:nvGrpSpPr>
        <p:grpSpPr>
          <a:xfrm>
            <a:off x="957526" y="2118360"/>
            <a:ext cx="1682496" cy="118872"/>
            <a:chOff x="957526" y="399812"/>
            <a:chExt cx="1645920" cy="91440"/>
          </a:xfrm>
        </p:grpSpPr>
        <p:sp>
          <p:nvSpPr>
            <p:cNvPr id="92" name="Rechteck 91"/>
            <p:cNvSpPr/>
            <p:nvPr/>
          </p:nvSpPr>
          <p:spPr>
            <a:xfrm>
              <a:off x="957526" y="399812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hteck 92"/>
            <p:cNvSpPr/>
            <p:nvPr/>
          </p:nvSpPr>
          <p:spPr>
            <a:xfrm>
              <a:off x="1780486" y="399812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Gruppieren 93"/>
          <p:cNvGrpSpPr/>
          <p:nvPr/>
        </p:nvGrpSpPr>
        <p:grpSpPr>
          <a:xfrm>
            <a:off x="957526" y="3904488"/>
            <a:ext cx="1682496" cy="118872"/>
            <a:chOff x="957526" y="399812"/>
            <a:chExt cx="1645920" cy="91440"/>
          </a:xfrm>
        </p:grpSpPr>
        <p:sp>
          <p:nvSpPr>
            <p:cNvPr id="95" name="Rechteck 94"/>
            <p:cNvSpPr/>
            <p:nvPr/>
          </p:nvSpPr>
          <p:spPr>
            <a:xfrm>
              <a:off x="957526" y="399812"/>
              <a:ext cx="8229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hteck 95"/>
            <p:cNvSpPr/>
            <p:nvPr/>
          </p:nvSpPr>
          <p:spPr>
            <a:xfrm>
              <a:off x="1780486" y="399812"/>
              <a:ext cx="82296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9955674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</Words>
  <Application>Microsoft Office PowerPoint</Application>
  <PresentationFormat>Bildschirmpräsentation (4:3)</PresentationFormat>
  <Paragraphs>6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33</cp:revision>
  <cp:lastPrinted>2020-05-07T08:20:04Z</cp:lastPrinted>
  <dcterms:created xsi:type="dcterms:W3CDTF">2020-04-21T14:10:58Z</dcterms:created>
  <dcterms:modified xsi:type="dcterms:W3CDTF">2021-09-21T13:07:08Z</dcterms:modified>
</cp:coreProperties>
</file>